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482" r:id="rId2"/>
    <p:sldId id="48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694"/>
  </p:normalViewPr>
  <p:slideViewPr>
    <p:cSldViewPr snapToGrid="0">
      <p:cViewPr varScale="1">
        <p:scale>
          <a:sx n="121" d="100"/>
          <a:sy n="121" d="100"/>
        </p:scale>
        <p:origin x="2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7D216-47C9-86CB-29D8-77975A9BAF5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1E44298-1B0D-67F0-6344-BF73E55068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83D61FD-51D6-738C-51D2-57F076AA8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70E08-54EE-8E76-CBA4-3EB86093D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D4F1EF-147E-34AB-9AFB-33CC78083A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1574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BFD432-5935-B607-DECD-D6D9111B4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1124BE-28D5-7DE2-CDB8-2677C3D69A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A2726B-5EB5-2942-C4B6-D87FC1E9B7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AF408-8F9B-7950-E8A1-DD7E757E38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425C23-DE77-84D8-BC3C-27D685F2A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7407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4E3760-0E24-50FE-F92E-6DE29AAD07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A143A5-4BF4-BC3D-8885-E2B4540AED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6F7430-41FE-B4BA-D252-9616ADF6A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5E0FD8-45A6-3E1D-1AE1-9654736C71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1CB349-567C-DA28-C78A-77ABC718E7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4823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lumns 1" userDrawn="1">
  <p:cSld name="Two columns 1">
    <p:spTree>
      <p:nvGrpSpPr>
        <p:cNvPr id="1" name="Shape 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le 1">
            <a:extLst>
              <a:ext uri="{FF2B5EF4-FFF2-40B4-BE49-F238E27FC236}">
                <a16:creationId xmlns:a16="http://schemas.microsoft.com/office/drawing/2014/main" id="{1F6FCDD4-B9A4-6A45-9BD6-A2E2D98F96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9" y="544073"/>
            <a:ext cx="10515600" cy="668732"/>
          </a:xfrm>
        </p:spPr>
        <p:txBody>
          <a:bodyPr>
            <a:normAutofit/>
          </a:bodyPr>
          <a:lstStyle>
            <a:lvl1pPr algn="l" defTabSz="914445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lang="en-US" sz="3200" b="1" kern="1200" dirty="0">
                <a:solidFill>
                  <a:srgbClr val="002173"/>
                </a:solidFill>
                <a:latin typeface="Arial" panose="020B0604020202020204" pitchFamily="34" charset="0"/>
                <a:ea typeface="+mj-ea"/>
                <a:cs typeface="Arial" panose="020B0604020202020204" pitchFamily="34" charset="0"/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2459BBC8-4318-E348-88B1-3C8886D3FF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199" y="1504114"/>
            <a:ext cx="10515600" cy="5269193"/>
          </a:xfrm>
        </p:spPr>
        <p:txBody>
          <a:bodyPr/>
          <a:lstStyle>
            <a:lvl1pPr>
              <a:defRPr sz="240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914445" indent="-457223">
              <a:buFont typeface="Wingdings" panose="05000000000000000000" pitchFamily="2" charset="2"/>
              <a:buChar char="§"/>
              <a:defRPr sz="1801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>
              <a:defRPr sz="1801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>
              <a:defRPr sz="1801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>
              <a:defRPr sz="1801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E66F29-F684-4EF8-6AEB-6BA101F8F080}"/>
              </a:ext>
            </a:extLst>
          </p:cNvPr>
          <p:cNvSpPr txBox="1"/>
          <p:nvPr userDrawn="1"/>
        </p:nvSpPr>
        <p:spPr>
          <a:xfrm>
            <a:off x="-51788" y="6634808"/>
            <a:ext cx="12295575" cy="276999"/>
          </a:xfrm>
          <a:prstGeom prst="rect">
            <a:avLst/>
          </a:prstGeom>
          <a:solidFill>
            <a:srgbClr val="452E6F"/>
          </a:solidFill>
          <a:ln>
            <a:noFill/>
          </a:ln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     </a:t>
            </a:r>
            <a:r>
              <a:rPr lang="en-US" sz="1200" dirty="0">
                <a:solidFill>
                  <a:srgbClr val="7030A0"/>
                </a:solidFill>
              </a:rPr>
              <a:t>		</a:t>
            </a:r>
            <a:r>
              <a:rPr lang="en-US" sz="1200" dirty="0">
                <a:solidFill>
                  <a:schemeClr val="bg1"/>
                </a:solidFill>
              </a:rPr>
              <a:t>	</a:t>
            </a:r>
          </a:p>
        </p:txBody>
      </p:sp>
    </p:spTree>
    <p:extLst>
      <p:ext uri="{BB962C8B-B14F-4D97-AF65-F5344CB8AC3E}">
        <p14:creationId xmlns:p14="http://schemas.microsoft.com/office/powerpoint/2010/main" val="3120769815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680">
          <p15:clr>
            <a:srgbClr val="FA7B17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9554EE-FEC5-C07A-8E12-E10E6C29C5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EAC339-4EDC-C7E3-36D2-70A3B1FF94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30CDA2-F164-4917-4E86-14B544BDA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F59DD7-9719-1442-5ABC-2F86E7D5B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935315-2029-2567-6E56-77F395040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39187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03596B-CCB8-6E70-EDEB-638C6C5A1B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C6DBDAA-DF40-6FD8-F34B-4EE09041DA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CBDCAC-659F-988A-A55C-9334353C2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4AE0BF-97E7-42D2-0F6B-3D460C7B9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3CACDE-9E1F-441D-99CC-8A626CB47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33111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32BBB-B086-B63E-7D87-B666D5D7DF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14EC05-DAB0-081C-BB36-B54D0F31C2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D6ACA6-1818-8D3A-0664-4D6071F55C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894B49-2B56-8ED1-949A-4A0A4F9048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2F55EC-D4D8-5105-835C-48830628E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2E63B0-4CDB-F3BD-2FC8-EAB854A47B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35412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BEE3C8-E6D6-85FA-119E-9AEAF91273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08C4FE-81A0-6933-A12E-F0857C48E6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57B17C-13C8-2747-7512-90AF39107C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E4F4524-5EDC-C82F-6024-F97B9145349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A3AE40-8773-E6CB-D177-AB4D060F59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E23528-EA4E-5353-8C0A-57AC89EC2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B160EC-8DD7-0B6A-CB57-4E439B93D0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CD99D17-EB07-3E8B-6840-81F1CEA504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674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617690-551F-E3A5-B3AC-EC25B14DC9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F666475-3EE8-8F3F-DC82-84A2AFF68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52444B7-E1D8-C379-9FB2-9792834F4E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7FCDE1-525D-EF11-1C76-B44DABEF34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4603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00E5ECA-BE60-87F6-ACA9-97628CDA9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CC1EFB-E3EB-BC50-AB5A-25A370EFC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E12982-9414-C726-CFDE-B5DD6F2074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173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02B466-44E3-9427-0EE8-1FB0B8D23F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669F32-8425-FB36-CA54-6464EC9285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17DEAE-8ED0-71F4-2C22-418DD1D163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7805CC-5D7A-E70E-F096-4CC098EF70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D100B2-73C3-F4D8-21CA-DE3103BBB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607C83-5725-382F-0102-D61E9A192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576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25DB1F-1204-DC18-5296-4214A22531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FABBAE-2B17-FED3-219C-6D70037615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969718-3D0F-173A-C1E5-0AEF9808F5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80DA1E2-3401-7855-0409-CC6A06087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33D5AA-2E32-9D1F-E13B-4168F60642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626B16-D6C1-E534-4D50-B31C0474E9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813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A130B82-BD28-9885-71EA-DF9432E64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102EA1-9024-7648-ECAF-C4BDF9B724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6EED30-AEF0-843B-6B1B-15EC9CF1635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72606-ABB3-FE45-A57C-5F99F6A59C67}" type="datetimeFigureOut">
              <a:rPr lang="en-US" smtClean="0"/>
              <a:t>5/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E912E4-FA03-EB46-23A8-AF1CD5FA00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587E4A-DA4E-0F94-5B00-F106F4A156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468993-554A-2647-9E7E-A7E9D112FF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49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2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305EC-96BC-3790-3BC3-2E5FA1335B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/>
                <a:cs typeface="Arial"/>
              </a:rPr>
              <a:t>Example of Twitter Account-Level Interface</a:t>
            </a:r>
            <a:endParaRPr lang="en-US" dirty="0"/>
          </a:p>
        </p:txBody>
      </p:sp>
      <p:pic>
        <p:nvPicPr>
          <p:cNvPr id="6" name="图片 5" descr="图形用户界面, 文本, 应用程序, 聊天或短信&#10;&#10;描述已自动生成">
            <a:extLst>
              <a:ext uri="{FF2B5EF4-FFF2-40B4-BE49-F238E27FC236}">
                <a16:creationId xmlns:a16="http://schemas.microsoft.com/office/drawing/2014/main" id="{7311CB03-93CB-EEE9-BF86-3454A50C4B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4223" y="1581370"/>
            <a:ext cx="4963554" cy="4474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54555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305EC-96BC-3790-3BC3-2E5FA1335B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198" y="544073"/>
            <a:ext cx="10996449" cy="668732"/>
          </a:xfrm>
        </p:spPr>
        <p:txBody>
          <a:bodyPr>
            <a:normAutofit fontScale="90000"/>
          </a:bodyPr>
          <a:lstStyle/>
          <a:p>
            <a:r>
              <a:rPr lang="en-US" dirty="0">
                <a:latin typeface="Arial"/>
                <a:cs typeface="Arial"/>
              </a:rPr>
              <a:t>Example of Tweet-Level Interface and Public Engagements</a:t>
            </a:r>
            <a:endParaRPr lang="en-US" dirty="0"/>
          </a:p>
        </p:txBody>
      </p:sp>
      <p:pic>
        <p:nvPicPr>
          <p:cNvPr id="5" name="图片 4" descr="手机截图图人的照片上写着字&#10;&#10;描述已自动生成">
            <a:extLst>
              <a:ext uri="{FF2B5EF4-FFF2-40B4-BE49-F238E27FC236}">
                <a16:creationId xmlns:a16="http://schemas.microsoft.com/office/drawing/2014/main" id="{0D5FCD3F-C11A-F5D6-FC18-DF47D64511F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3726" y="1353755"/>
            <a:ext cx="3656009" cy="4881450"/>
          </a:xfrm>
          <a:prstGeom prst="rect">
            <a:avLst/>
          </a:prstGeom>
        </p:spPr>
      </p:pic>
      <p:pic>
        <p:nvPicPr>
          <p:cNvPr id="7" name="图片 6" descr="图片包含 图形用户界面&#10;&#10;描述已自动生成">
            <a:extLst>
              <a:ext uri="{FF2B5EF4-FFF2-40B4-BE49-F238E27FC236}">
                <a16:creationId xmlns:a16="http://schemas.microsoft.com/office/drawing/2014/main" id="{A1A3CB13-A3D0-051C-1112-7231560DBFB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1508917"/>
            <a:ext cx="5122976" cy="997503"/>
          </a:xfrm>
          <a:prstGeom prst="rect">
            <a:avLst/>
          </a:prstGeom>
        </p:spPr>
      </p:pic>
      <p:pic>
        <p:nvPicPr>
          <p:cNvPr id="10" name="图片 9" descr="图形用户界面&#10;&#10;中度可信度描述已自动生成">
            <a:extLst>
              <a:ext uri="{FF2B5EF4-FFF2-40B4-BE49-F238E27FC236}">
                <a16:creationId xmlns:a16="http://schemas.microsoft.com/office/drawing/2014/main" id="{391E4947-79B0-12FD-E565-6547779A72B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36703" y="3100472"/>
            <a:ext cx="4758329" cy="2904064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4E444A9A-55CF-1DB5-C20E-A6631743F50A}"/>
              </a:ext>
            </a:extLst>
          </p:cNvPr>
          <p:cNvSpPr txBox="1"/>
          <p:nvPr/>
        </p:nvSpPr>
        <p:spPr>
          <a:xfrm>
            <a:off x="7679410" y="4362773"/>
            <a:ext cx="184731" cy="3794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17926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2</Words>
  <Application>Microsoft Macintosh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Wingdings</vt:lpstr>
      <vt:lpstr>Office Theme</vt:lpstr>
      <vt:lpstr>Example of Twitter Account-Level Interface</vt:lpstr>
      <vt:lpstr>Example of Tweet-Level Interface and Public Engagement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xample of Twitter Account</dc:title>
  <dc:creator>Ling Mao</dc:creator>
  <cp:lastModifiedBy>Ling Mao</cp:lastModifiedBy>
  <cp:revision>2</cp:revision>
  <dcterms:created xsi:type="dcterms:W3CDTF">2023-05-09T19:39:42Z</dcterms:created>
  <dcterms:modified xsi:type="dcterms:W3CDTF">2023-05-09T20:28:08Z</dcterms:modified>
</cp:coreProperties>
</file>